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theme/themeOverride1.xml" ContentType="application/vnd.openxmlformats-officedocument.themeOverride+xml"/>
  <Override PartName="/ppt/charts/chart3.xml" ContentType="application/vnd.openxmlformats-officedocument.drawingml.chart+xml"/>
  <Override PartName="/ppt/theme/themeOverride2.xml" ContentType="application/vnd.openxmlformats-officedocument.themeOverride+xml"/>
  <Override PartName="/ppt/charts/chart4.xml" ContentType="application/vnd.openxmlformats-officedocument.drawingml.chart+xml"/>
  <Override PartName="/ppt/theme/themeOverride3.xml" ContentType="application/vnd.openxmlformats-officedocument.themeOverride+xml"/>
  <Override PartName="/ppt/charts/chart5.xml" ContentType="application/vnd.openxmlformats-officedocument.drawingml.chart+xml"/>
  <Override PartName="/ppt/theme/themeOverride4.xml" ContentType="application/vnd.openxmlformats-officedocument.themeOverride+xml"/>
  <Override PartName="/ppt/charts/chart6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3" r:id="rId2"/>
  </p:sldIdLst>
  <p:sldSz cx="6400800" cy="82296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snapVertSplitter="1" vertBarState="minimized" horzBarState="maximized">
    <p:restoredLeft sz="4650" autoAdjust="0"/>
    <p:restoredTop sz="94420" autoAdjust="0"/>
  </p:normalViewPr>
  <p:slideViewPr>
    <p:cSldViewPr>
      <p:cViewPr>
        <p:scale>
          <a:sx n="90" d="100"/>
          <a:sy n="90" d="100"/>
        </p:scale>
        <p:origin x="-3804" y="-336"/>
      </p:cViewPr>
      <p:guideLst>
        <p:guide orient="horz" pos="2592"/>
        <p:guide pos="2016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medctr\dfs\canbio2$\cfahrenh\Lab%20Work\GSH-GSSG%20Kit\2016-09-22%20GSSH%20GSG%20AgNP%20BSO%20OvCa.xlsx" TargetMode="Externa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oleObject" Target="file:///\\medctr\dfs\canbio2$\cfahrenh\Lab%20Work\GSH-GSSG%20Kit\2016-09-22%20GSSH%20GSG%20AgNP%20BSO%20OvCa.xlsx" TargetMode="External"/><Relationship Id="rId1" Type="http://schemas.openxmlformats.org/officeDocument/2006/relationships/themeOverride" Target="../theme/themeOverride1.xml"/></Relationships>
</file>

<file path=ppt/charts/_rels/chart3.xml.rels><?xml version="1.0" encoding="UTF-8" standalone="yes"?>
<Relationships xmlns="http://schemas.openxmlformats.org/package/2006/relationships"><Relationship Id="rId2" Type="http://schemas.openxmlformats.org/officeDocument/2006/relationships/oleObject" Target="file:///\\medctr\dfs\canbio2$\cfahrenh\Lab%20Work\GSH-GSSG%20Kit\2016-09-22%20GSSH%20GSG%20AgNP%20BSO%20OvCa.xlsx" TargetMode="External"/><Relationship Id="rId1" Type="http://schemas.openxmlformats.org/officeDocument/2006/relationships/themeOverride" Target="../theme/themeOverride2.xml"/></Relationships>
</file>

<file path=ppt/charts/_rels/chart4.xml.rels><?xml version="1.0" encoding="UTF-8" standalone="yes"?>
<Relationships xmlns="http://schemas.openxmlformats.org/package/2006/relationships"><Relationship Id="rId2" Type="http://schemas.openxmlformats.org/officeDocument/2006/relationships/oleObject" Target="file:///\\medctr\dfs\canbio2$\cfahrenh\Lab%20Work\GSH-GSSG%20Kit\2016-09-22%20GSSH%20GSG%20AgNP%20BSO%20OvCa.xlsx" TargetMode="External"/><Relationship Id="rId1" Type="http://schemas.openxmlformats.org/officeDocument/2006/relationships/themeOverride" Target="../theme/themeOverride3.xml"/></Relationships>
</file>

<file path=ppt/charts/_rels/chart5.xml.rels><?xml version="1.0" encoding="UTF-8" standalone="yes"?>
<Relationships xmlns="http://schemas.openxmlformats.org/package/2006/relationships"><Relationship Id="rId2" Type="http://schemas.openxmlformats.org/officeDocument/2006/relationships/oleObject" Target="file:///\\medctr\dfs\canbio2$\cfahrenh\Lab%20Work\GSH-GSSG%20Kit\2016-09-22%20GSSH%20GSG%20AgNP%20BSO%20OvCa.xlsx" TargetMode="External"/><Relationship Id="rId1" Type="http://schemas.openxmlformats.org/officeDocument/2006/relationships/themeOverride" Target="../theme/themeOverride4.xm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\\medctr\dfs\canbio2$\cfahrenh\Lab%20Work\GSH-GSSG%20Kit\2016-09-22%20GSSH%20GSG%20AgNP%20BSO%20OvCa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A2780'!$J$37</c:f>
              <c:strCache>
                <c:ptCount val="1"/>
                <c:pt idx="0">
                  <c:v>Percent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A2780'!$K$38:$N$38</c:f>
                <c:numCache>
                  <c:formatCode>General</c:formatCode>
                  <c:ptCount val="4"/>
                  <c:pt idx="0">
                    <c:v>8.6595224784302847</c:v>
                  </c:pt>
                  <c:pt idx="1">
                    <c:v>9.798001759448832</c:v>
                  </c:pt>
                  <c:pt idx="2">
                    <c:v>8.0352262738563418</c:v>
                  </c:pt>
                  <c:pt idx="3">
                    <c:v>14.13543758131075</c:v>
                  </c:pt>
                </c:numCache>
              </c:numRef>
            </c:plus>
            <c:minus>
              <c:numRef>
                <c:f>'A2780'!$K$38:$N$38</c:f>
                <c:numCache>
                  <c:formatCode>General</c:formatCode>
                  <c:ptCount val="4"/>
                  <c:pt idx="0">
                    <c:v>8.6595224784302847</c:v>
                  </c:pt>
                  <c:pt idx="1">
                    <c:v>9.798001759448832</c:v>
                  </c:pt>
                  <c:pt idx="2">
                    <c:v>8.0352262738563418</c:v>
                  </c:pt>
                  <c:pt idx="3">
                    <c:v>14.13543758131075</c:v>
                  </c:pt>
                </c:numCache>
              </c:numRef>
            </c:minus>
          </c:errBars>
          <c:cat>
            <c:strRef>
              <c:f>'A2780'!$K$36:$M$36</c:f>
              <c:strCache>
                <c:ptCount val="3"/>
                <c:pt idx="0">
                  <c:v>Veh</c:v>
                </c:pt>
                <c:pt idx="1">
                  <c:v>10 µg/ml AgNP</c:v>
                </c:pt>
                <c:pt idx="2">
                  <c:v>100 µg/ml AgNP</c:v>
                </c:pt>
              </c:strCache>
            </c:strRef>
          </c:cat>
          <c:val>
            <c:numRef>
              <c:f>'A2780'!$K$37:$M$37</c:f>
              <c:numCache>
                <c:formatCode>General</c:formatCode>
                <c:ptCount val="3"/>
                <c:pt idx="0">
                  <c:v>100</c:v>
                </c:pt>
                <c:pt idx="1">
                  <c:v>76.251549265980159</c:v>
                </c:pt>
                <c:pt idx="2">
                  <c:v>64.68270219107567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57632640"/>
        <c:axId val="57634176"/>
      </c:barChart>
      <c:catAx>
        <c:axId val="57632640"/>
        <c:scaling>
          <c:orientation val="minMax"/>
        </c:scaling>
        <c:delete val="0"/>
        <c:axPos val="b"/>
        <c:majorTickMark val="out"/>
        <c:minorTickMark val="none"/>
        <c:tickLblPos val="none"/>
        <c:crossAx val="57634176"/>
        <c:crosses val="autoZero"/>
        <c:auto val="1"/>
        <c:lblAlgn val="ctr"/>
        <c:lblOffset val="100"/>
        <c:noMultiLvlLbl val="0"/>
      </c:catAx>
      <c:valAx>
        <c:axId val="5763417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00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57632640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800"/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KOV3!$J$37</c:f>
              <c:strCache>
                <c:ptCount val="1"/>
                <c:pt idx="0">
                  <c:v>Percent</c:v>
                </c:pt>
              </c:strCache>
            </c:strRef>
          </c:tx>
          <c:spPr>
            <a:solidFill>
              <a:sysClr val="window" lastClr="FFFFFF">
                <a:lumMod val="50000"/>
              </a:sysClr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KOV3!$K$38:$N$38</c:f>
                <c:numCache>
                  <c:formatCode>General</c:formatCode>
                  <c:ptCount val="4"/>
                  <c:pt idx="0">
                    <c:v>2.1405627117245523</c:v>
                  </c:pt>
                  <c:pt idx="1">
                    <c:v>6.2255479941499532</c:v>
                  </c:pt>
                  <c:pt idx="2">
                    <c:v>1.7056112849810137</c:v>
                  </c:pt>
                  <c:pt idx="3">
                    <c:v>3.5934673260969765</c:v>
                  </c:pt>
                </c:numCache>
              </c:numRef>
            </c:plus>
            <c:minus>
              <c:numRef>
                <c:f>SKOV3!$K$38:$N$38</c:f>
                <c:numCache>
                  <c:formatCode>General</c:formatCode>
                  <c:ptCount val="4"/>
                  <c:pt idx="0">
                    <c:v>2.1405627117245523</c:v>
                  </c:pt>
                  <c:pt idx="1">
                    <c:v>6.2255479941499532</c:v>
                  </c:pt>
                  <c:pt idx="2">
                    <c:v>1.7056112849810137</c:v>
                  </c:pt>
                  <c:pt idx="3">
                    <c:v>3.5934673260969765</c:v>
                  </c:pt>
                </c:numCache>
              </c:numRef>
            </c:minus>
          </c:errBars>
          <c:cat>
            <c:strRef>
              <c:f>SKOV3!$K$36:$M$36</c:f>
              <c:strCache>
                <c:ptCount val="3"/>
                <c:pt idx="0">
                  <c:v>Veh</c:v>
                </c:pt>
                <c:pt idx="1">
                  <c:v>10 µg/ml AgNP</c:v>
                </c:pt>
                <c:pt idx="2">
                  <c:v>100 µg/ml AgNP</c:v>
                </c:pt>
              </c:strCache>
            </c:strRef>
          </c:cat>
          <c:val>
            <c:numRef>
              <c:f>SKOV3!$K$37:$M$37</c:f>
              <c:numCache>
                <c:formatCode>General</c:formatCode>
                <c:ptCount val="3"/>
                <c:pt idx="0">
                  <c:v>100</c:v>
                </c:pt>
                <c:pt idx="1">
                  <c:v>95.306550045617286</c:v>
                </c:pt>
                <c:pt idx="2">
                  <c:v>71.06371307938154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57666560"/>
        <c:axId val="57672448"/>
      </c:barChart>
      <c:catAx>
        <c:axId val="57666560"/>
        <c:scaling>
          <c:orientation val="minMax"/>
        </c:scaling>
        <c:delete val="0"/>
        <c:axPos val="b"/>
        <c:majorTickMark val="out"/>
        <c:minorTickMark val="none"/>
        <c:tickLblPos val="none"/>
        <c:crossAx val="57672448"/>
        <c:crosses val="autoZero"/>
        <c:auto val="1"/>
        <c:lblAlgn val="ctr"/>
        <c:lblOffset val="100"/>
        <c:noMultiLvlLbl val="0"/>
      </c:catAx>
      <c:valAx>
        <c:axId val="5767244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00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57666560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800"/>
      </a:pPr>
      <a:endParaRPr lang="en-US"/>
    </a:p>
  </c:txPr>
  <c:externalData r:id="rId2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OVCAR3!$J$37</c:f>
              <c:strCache>
                <c:ptCount val="1"/>
                <c:pt idx="0">
                  <c:v>Percent</c:v>
                </c:pt>
              </c:strCache>
            </c:strRef>
          </c:tx>
          <c:spPr>
            <a:solidFill>
              <a:sysClr val="window" lastClr="FFFFFF">
                <a:lumMod val="50000"/>
              </a:sysClr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OVCAR3!$K$38:$N$38</c:f>
                <c:numCache>
                  <c:formatCode>General</c:formatCode>
                  <c:ptCount val="4"/>
                  <c:pt idx="0">
                    <c:v>7.4049279226852311</c:v>
                  </c:pt>
                  <c:pt idx="1">
                    <c:v>6.4773807324631134</c:v>
                  </c:pt>
                  <c:pt idx="2">
                    <c:v>6.9073187675764824</c:v>
                  </c:pt>
                  <c:pt idx="3">
                    <c:v>6.3168562850499255</c:v>
                  </c:pt>
                </c:numCache>
              </c:numRef>
            </c:plus>
            <c:minus>
              <c:numRef>
                <c:f>OVCAR3!$K$38:$N$38</c:f>
                <c:numCache>
                  <c:formatCode>General</c:formatCode>
                  <c:ptCount val="4"/>
                  <c:pt idx="0">
                    <c:v>7.4049279226852311</c:v>
                  </c:pt>
                  <c:pt idx="1">
                    <c:v>6.4773807324631134</c:v>
                  </c:pt>
                  <c:pt idx="2">
                    <c:v>6.9073187675764824</c:v>
                  </c:pt>
                  <c:pt idx="3">
                    <c:v>6.3168562850499255</c:v>
                  </c:pt>
                </c:numCache>
              </c:numRef>
            </c:minus>
          </c:errBars>
          <c:cat>
            <c:strRef>
              <c:f>OVCAR3!$K$36:$M$36</c:f>
              <c:strCache>
                <c:ptCount val="3"/>
                <c:pt idx="0">
                  <c:v>Veh</c:v>
                </c:pt>
                <c:pt idx="1">
                  <c:v>10 µg/ml AgNP</c:v>
                </c:pt>
                <c:pt idx="2">
                  <c:v>100 µg/ml AgNP</c:v>
                </c:pt>
              </c:strCache>
            </c:strRef>
          </c:cat>
          <c:val>
            <c:numRef>
              <c:f>OVCAR3!$K$37:$M$37</c:f>
              <c:numCache>
                <c:formatCode>General</c:formatCode>
                <c:ptCount val="3"/>
                <c:pt idx="0">
                  <c:v>100</c:v>
                </c:pt>
                <c:pt idx="1">
                  <c:v>91.777561067312092</c:v>
                </c:pt>
                <c:pt idx="2">
                  <c:v>92.10231344949536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57725312"/>
        <c:axId val="57726848"/>
      </c:barChart>
      <c:catAx>
        <c:axId val="57725312"/>
        <c:scaling>
          <c:orientation val="minMax"/>
        </c:scaling>
        <c:delete val="0"/>
        <c:axPos val="b"/>
        <c:majorTickMark val="out"/>
        <c:minorTickMark val="none"/>
        <c:tickLblPos val="none"/>
        <c:crossAx val="57726848"/>
        <c:crosses val="autoZero"/>
        <c:auto val="1"/>
        <c:lblAlgn val="ctr"/>
        <c:lblOffset val="100"/>
        <c:noMultiLvlLbl val="0"/>
      </c:catAx>
      <c:valAx>
        <c:axId val="5772684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00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57725312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800"/>
      </a:pPr>
      <a:endParaRPr lang="en-US"/>
    </a:p>
  </c:txPr>
  <c:externalData r:id="rId2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OVCAR3!$T$26</c:f>
              <c:strCache>
                <c:ptCount val="1"/>
                <c:pt idx="0">
                  <c:v>Vehicle</c:v>
                </c:pt>
              </c:strCache>
            </c:strRef>
          </c:tx>
          <c:spPr>
            <a:solidFill>
              <a:sysClr val="window" lastClr="FFFFFF">
                <a:lumMod val="50000"/>
              </a:sysClr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OVCAR3!$U$29:$V$29</c:f>
                <c:numCache>
                  <c:formatCode>General</c:formatCode>
                  <c:ptCount val="2"/>
                  <c:pt idx="0">
                    <c:v>0.22349995958725466</c:v>
                  </c:pt>
                  <c:pt idx="1">
                    <c:v>4.4899286751979704E-2</c:v>
                  </c:pt>
                </c:numCache>
              </c:numRef>
            </c:plus>
            <c:minus>
              <c:numRef>
                <c:f>OVCAR3!$U$29:$V$29</c:f>
                <c:numCache>
                  <c:formatCode>General</c:formatCode>
                  <c:ptCount val="2"/>
                  <c:pt idx="0">
                    <c:v>0.22349995958725466</c:v>
                  </c:pt>
                  <c:pt idx="1">
                    <c:v>4.4899286751979704E-2</c:v>
                  </c:pt>
                </c:numCache>
              </c:numRef>
            </c:minus>
          </c:errBars>
          <c:cat>
            <c:strRef>
              <c:f>OVCAR3!$V$25</c:f>
              <c:strCache>
                <c:ptCount val="1"/>
                <c:pt idx="0">
                  <c:v>Total</c:v>
                </c:pt>
              </c:strCache>
            </c:strRef>
          </c:cat>
          <c:val>
            <c:numRef>
              <c:f>OVCAR3!$V$26</c:f>
              <c:numCache>
                <c:formatCode>General</c:formatCode>
                <c:ptCount val="1"/>
                <c:pt idx="0">
                  <c:v>1</c:v>
                </c:pt>
              </c:numCache>
            </c:numRef>
          </c:val>
        </c:ser>
        <c:ser>
          <c:idx val="1"/>
          <c:order val="1"/>
          <c:tx>
            <c:strRef>
              <c:f>OVCAR3!$T$27</c:f>
              <c:strCache>
                <c:ptCount val="1"/>
                <c:pt idx="0">
                  <c:v>BSO</c:v>
                </c:pt>
              </c:strCache>
            </c:strRef>
          </c:tx>
          <c:spPr>
            <a:solidFill>
              <a:sysClr val="window" lastClr="FFFFFF"/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OVCAR3!$U$30:$V$30</c:f>
                <c:numCache>
                  <c:formatCode>General</c:formatCode>
                  <c:ptCount val="2"/>
                  <c:pt idx="0">
                    <c:v>3.4778902588578485E-2</c:v>
                  </c:pt>
                  <c:pt idx="1">
                    <c:v>1.5925616573617279E-2</c:v>
                  </c:pt>
                </c:numCache>
              </c:numRef>
            </c:plus>
            <c:minus>
              <c:numRef>
                <c:f>OVCAR3!$U$30:$V$30</c:f>
                <c:numCache>
                  <c:formatCode>General</c:formatCode>
                  <c:ptCount val="2"/>
                  <c:pt idx="0">
                    <c:v>3.4778902588578485E-2</c:v>
                  </c:pt>
                  <c:pt idx="1">
                    <c:v>1.5925616573617279E-2</c:v>
                  </c:pt>
                </c:numCache>
              </c:numRef>
            </c:minus>
          </c:errBars>
          <c:cat>
            <c:strRef>
              <c:f>OVCAR3!$V$25</c:f>
              <c:strCache>
                <c:ptCount val="1"/>
                <c:pt idx="0">
                  <c:v>Total</c:v>
                </c:pt>
              </c:strCache>
            </c:strRef>
          </c:cat>
          <c:val>
            <c:numRef>
              <c:f>OVCAR3!$V$27</c:f>
              <c:numCache>
                <c:formatCode>General</c:formatCode>
                <c:ptCount val="1"/>
                <c:pt idx="0">
                  <c:v>0.117427655704859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57756288"/>
        <c:axId val="57782656"/>
      </c:barChart>
      <c:catAx>
        <c:axId val="57756288"/>
        <c:scaling>
          <c:orientation val="minMax"/>
        </c:scaling>
        <c:delete val="0"/>
        <c:axPos val="b"/>
        <c:majorTickMark val="out"/>
        <c:minorTickMark val="none"/>
        <c:tickLblPos val="none"/>
        <c:crossAx val="57782656"/>
        <c:crosses val="autoZero"/>
        <c:auto val="1"/>
        <c:lblAlgn val="ctr"/>
        <c:lblOffset val="100"/>
        <c:noMultiLvlLbl val="0"/>
      </c:catAx>
      <c:valAx>
        <c:axId val="5778265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00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57756288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62624036181438503"/>
          <c:y val="0.32112219812666265"/>
          <c:w val="0.32788880643325791"/>
          <c:h val="0.23199474828239425"/>
        </c:manualLayout>
      </c:layout>
      <c:overlay val="1"/>
      <c:txPr>
        <a:bodyPr/>
        <a:lstStyle/>
        <a:p>
          <a:pPr>
            <a:defRPr sz="800" b="1">
              <a:latin typeface="Arial" panose="020B0604020202020204" pitchFamily="34" charset="0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txPr>
    <a:bodyPr/>
    <a:lstStyle/>
    <a:p>
      <a:pPr>
        <a:defRPr sz="1800"/>
      </a:pPr>
      <a:endParaRPr lang="en-US"/>
    </a:p>
  </c:txPr>
  <c:externalData r:id="rId2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KOV3!$T$26</c:f>
              <c:strCache>
                <c:ptCount val="1"/>
                <c:pt idx="0">
                  <c:v>Vehicle</c:v>
                </c:pt>
              </c:strCache>
            </c:strRef>
          </c:tx>
          <c:spPr>
            <a:solidFill>
              <a:sysClr val="window" lastClr="FFFFFF">
                <a:lumMod val="50000"/>
              </a:sysClr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KOV3!$U$29:$V$29</c:f>
                <c:numCache>
                  <c:formatCode>General</c:formatCode>
                  <c:ptCount val="2"/>
                  <c:pt idx="0">
                    <c:v>9.0061628355461901E-2</c:v>
                  </c:pt>
                  <c:pt idx="1">
                    <c:v>5.9850408572097683E-2</c:v>
                  </c:pt>
                </c:numCache>
              </c:numRef>
            </c:plus>
            <c:minus>
              <c:numRef>
                <c:f>SKOV3!$U$29:$V$29</c:f>
                <c:numCache>
                  <c:formatCode>General</c:formatCode>
                  <c:ptCount val="2"/>
                  <c:pt idx="0">
                    <c:v>9.0061628355461901E-2</c:v>
                  </c:pt>
                  <c:pt idx="1">
                    <c:v>5.9850408572097683E-2</c:v>
                  </c:pt>
                </c:numCache>
              </c:numRef>
            </c:minus>
          </c:errBars>
          <c:cat>
            <c:strRef>
              <c:f>SKOV3!$V$25</c:f>
              <c:strCache>
                <c:ptCount val="1"/>
                <c:pt idx="0">
                  <c:v>Total</c:v>
                </c:pt>
              </c:strCache>
            </c:strRef>
          </c:cat>
          <c:val>
            <c:numRef>
              <c:f>SKOV3!$V$26</c:f>
              <c:numCache>
                <c:formatCode>General</c:formatCode>
                <c:ptCount val="1"/>
                <c:pt idx="0">
                  <c:v>1</c:v>
                </c:pt>
              </c:numCache>
            </c:numRef>
          </c:val>
        </c:ser>
        <c:ser>
          <c:idx val="1"/>
          <c:order val="1"/>
          <c:tx>
            <c:strRef>
              <c:f>SKOV3!$T$27</c:f>
              <c:strCache>
                <c:ptCount val="1"/>
                <c:pt idx="0">
                  <c:v>BSO</c:v>
                </c:pt>
              </c:strCache>
            </c:strRef>
          </c:tx>
          <c:spPr>
            <a:solidFill>
              <a:sysClr val="window" lastClr="FFFFFF"/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KOV3!$U$30:$V$30</c:f>
                <c:numCache>
                  <c:formatCode>General</c:formatCode>
                  <c:ptCount val="2"/>
                  <c:pt idx="0">
                    <c:v>3.8340630232521766E-2</c:v>
                  </c:pt>
                  <c:pt idx="1">
                    <c:v>8.3673590838921272E-3</c:v>
                  </c:pt>
                </c:numCache>
              </c:numRef>
            </c:plus>
            <c:minus>
              <c:numRef>
                <c:f>SKOV3!$U$30:$V$30</c:f>
                <c:numCache>
                  <c:formatCode>General</c:formatCode>
                  <c:ptCount val="2"/>
                  <c:pt idx="0">
                    <c:v>3.8340630232521766E-2</c:v>
                  </c:pt>
                  <c:pt idx="1">
                    <c:v>8.3673590838921272E-3</c:v>
                  </c:pt>
                </c:numCache>
              </c:numRef>
            </c:minus>
          </c:errBars>
          <c:cat>
            <c:strRef>
              <c:f>SKOV3!$V$25</c:f>
              <c:strCache>
                <c:ptCount val="1"/>
                <c:pt idx="0">
                  <c:v>Total</c:v>
                </c:pt>
              </c:strCache>
            </c:strRef>
          </c:cat>
          <c:val>
            <c:numRef>
              <c:f>SKOV3!$V$27</c:f>
              <c:numCache>
                <c:formatCode>General</c:formatCode>
                <c:ptCount val="1"/>
                <c:pt idx="0">
                  <c:v>0.247343070112784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57808384"/>
        <c:axId val="57809920"/>
      </c:barChart>
      <c:catAx>
        <c:axId val="57808384"/>
        <c:scaling>
          <c:orientation val="minMax"/>
        </c:scaling>
        <c:delete val="0"/>
        <c:axPos val="b"/>
        <c:majorTickMark val="out"/>
        <c:minorTickMark val="none"/>
        <c:tickLblPos val="none"/>
        <c:crossAx val="57809920"/>
        <c:crosses val="autoZero"/>
        <c:auto val="1"/>
        <c:lblAlgn val="ctr"/>
        <c:lblOffset val="100"/>
        <c:noMultiLvlLbl val="0"/>
      </c:catAx>
      <c:valAx>
        <c:axId val="5780992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00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57808384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63891530763710713"/>
          <c:y val="0.2983334070600725"/>
          <c:w val="0.3142682129621438"/>
          <c:h val="0.23167276141044169"/>
        </c:manualLayout>
      </c:layout>
      <c:overlay val="1"/>
      <c:txPr>
        <a:bodyPr/>
        <a:lstStyle/>
        <a:p>
          <a:pPr>
            <a:defRPr sz="800">
              <a:latin typeface="Arial" panose="020B0604020202020204" pitchFamily="34" charset="0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txPr>
    <a:bodyPr/>
    <a:lstStyle/>
    <a:p>
      <a:pPr>
        <a:defRPr sz="1800"/>
      </a:pPr>
      <a:endParaRPr lang="en-US"/>
    </a:p>
  </c:txPr>
  <c:externalData r:id="rId2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A2780'!$T$26</c:f>
              <c:strCache>
                <c:ptCount val="1"/>
                <c:pt idx="0">
                  <c:v>Vehicle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A2780'!$U$29:$V$29</c:f>
                <c:numCache>
                  <c:formatCode>General</c:formatCode>
                  <c:ptCount val="2"/>
                  <c:pt idx="0">
                    <c:v>8.0665793605904229E-2</c:v>
                  </c:pt>
                  <c:pt idx="1">
                    <c:v>0.10024621532219817</c:v>
                  </c:pt>
                </c:numCache>
              </c:numRef>
            </c:plus>
            <c:minus>
              <c:numRef>
                <c:f>'A2780'!$U$29:$V$29</c:f>
                <c:numCache>
                  <c:formatCode>General</c:formatCode>
                  <c:ptCount val="2"/>
                  <c:pt idx="0">
                    <c:v>8.0665793605904229E-2</c:v>
                  </c:pt>
                  <c:pt idx="1">
                    <c:v>0.10024621532219817</c:v>
                  </c:pt>
                </c:numCache>
              </c:numRef>
            </c:minus>
          </c:errBars>
          <c:cat>
            <c:strRef>
              <c:f>'A2780'!$V$25</c:f>
              <c:strCache>
                <c:ptCount val="1"/>
                <c:pt idx="0">
                  <c:v>Total</c:v>
                </c:pt>
              </c:strCache>
            </c:strRef>
          </c:cat>
          <c:val>
            <c:numRef>
              <c:f>'A2780'!$V$26</c:f>
              <c:numCache>
                <c:formatCode>General</c:formatCode>
                <c:ptCount val="1"/>
                <c:pt idx="0">
                  <c:v>1</c:v>
                </c:pt>
              </c:numCache>
            </c:numRef>
          </c:val>
        </c:ser>
        <c:ser>
          <c:idx val="1"/>
          <c:order val="1"/>
          <c:tx>
            <c:strRef>
              <c:f>'A2780'!$T$27</c:f>
              <c:strCache>
                <c:ptCount val="1"/>
                <c:pt idx="0">
                  <c:v>BSO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A2780'!$U$30:$V$30</c:f>
                <c:numCache>
                  <c:formatCode>General</c:formatCode>
                  <c:ptCount val="2"/>
                  <c:pt idx="0">
                    <c:v>2.7406940029140174E-2</c:v>
                  </c:pt>
                  <c:pt idx="1">
                    <c:v>2.3521500824180506E-2</c:v>
                  </c:pt>
                </c:numCache>
              </c:numRef>
            </c:plus>
            <c:minus>
              <c:numRef>
                <c:f>'A2780'!$U$30:$V$30</c:f>
                <c:numCache>
                  <c:formatCode>General</c:formatCode>
                  <c:ptCount val="2"/>
                  <c:pt idx="0">
                    <c:v>2.7406940029140174E-2</c:v>
                  </c:pt>
                  <c:pt idx="1">
                    <c:v>2.3521500824180506E-2</c:v>
                  </c:pt>
                </c:numCache>
              </c:numRef>
            </c:minus>
          </c:errBars>
          <c:cat>
            <c:strRef>
              <c:f>'A2780'!$V$25</c:f>
              <c:strCache>
                <c:ptCount val="1"/>
                <c:pt idx="0">
                  <c:v>Total</c:v>
                </c:pt>
              </c:strCache>
            </c:strRef>
          </c:cat>
          <c:val>
            <c:numRef>
              <c:f>'A2780'!$V$27</c:f>
              <c:numCache>
                <c:formatCode>General</c:formatCode>
                <c:ptCount val="1"/>
                <c:pt idx="0">
                  <c:v>0.1290115878147101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57860480"/>
        <c:axId val="57862016"/>
      </c:barChart>
      <c:catAx>
        <c:axId val="57860480"/>
        <c:scaling>
          <c:orientation val="minMax"/>
        </c:scaling>
        <c:delete val="0"/>
        <c:axPos val="b"/>
        <c:majorTickMark val="out"/>
        <c:minorTickMark val="none"/>
        <c:tickLblPos val="none"/>
        <c:crossAx val="57862016"/>
        <c:crosses val="autoZero"/>
        <c:auto val="1"/>
        <c:lblAlgn val="ctr"/>
        <c:lblOffset val="100"/>
        <c:noMultiLvlLbl val="0"/>
      </c:catAx>
      <c:valAx>
        <c:axId val="5786201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00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57860480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62624036181438503"/>
          <c:y val="0.32112219812666265"/>
          <c:w val="0.32788880643325791"/>
          <c:h val="0.23199474828239425"/>
        </c:manualLayout>
      </c:layout>
      <c:overlay val="1"/>
      <c:txPr>
        <a:bodyPr/>
        <a:lstStyle/>
        <a:p>
          <a:pPr>
            <a:defRPr sz="800" b="1">
              <a:latin typeface="Arial" panose="020B0604020202020204" pitchFamily="34" charset="0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txPr>
    <a:bodyPr/>
    <a:lstStyle/>
    <a:p>
      <a:pPr>
        <a:defRPr sz="1800"/>
      </a:pPr>
      <a:endParaRPr lang="en-US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FC24FC9-0FF6-4877-8945-D5787F85793B}" type="datetimeFigureOut">
              <a:rPr lang="en-US" smtClean="0"/>
              <a:t>3/28/20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095500" y="685800"/>
            <a:ext cx="2667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3DC12D2-479F-493B-99B2-6B96415371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068565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80060" y="2556511"/>
            <a:ext cx="5440680" cy="1764030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60120" y="4663440"/>
            <a:ext cx="4480560" cy="210312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B8CD5-3A83-4C99-AC1D-3342DEA67A38}" type="datetimeFigureOut">
              <a:rPr lang="en-US" smtClean="0"/>
              <a:t>3/2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75B61C-C1C8-4546-B7B3-2B280C36BB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25001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B8CD5-3A83-4C99-AC1D-3342DEA67A38}" type="datetimeFigureOut">
              <a:rPr lang="en-US" smtClean="0"/>
              <a:t>3/2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75B61C-C1C8-4546-B7B3-2B280C36BB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3771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248184" y="396240"/>
            <a:ext cx="1007903" cy="8425816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24472" y="396240"/>
            <a:ext cx="2917032" cy="8425816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B8CD5-3A83-4C99-AC1D-3342DEA67A38}" type="datetimeFigureOut">
              <a:rPr lang="en-US" smtClean="0"/>
              <a:t>3/2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75B61C-C1C8-4546-B7B3-2B280C36BB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85728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B8CD5-3A83-4C99-AC1D-3342DEA67A38}" type="datetimeFigureOut">
              <a:rPr lang="en-US" smtClean="0"/>
              <a:t>3/2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75B61C-C1C8-4546-B7B3-2B280C36BB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11589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5619" y="5288281"/>
            <a:ext cx="5440680" cy="163449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5619" y="3488056"/>
            <a:ext cx="5440680" cy="1800224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B8CD5-3A83-4C99-AC1D-3342DEA67A38}" type="datetimeFigureOut">
              <a:rPr lang="en-US" smtClean="0"/>
              <a:t>3/2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75B61C-C1C8-4546-B7B3-2B280C36BB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97720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24473" y="2305050"/>
            <a:ext cx="1962468" cy="6517006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293620" y="2305050"/>
            <a:ext cx="1962468" cy="6517006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B8CD5-3A83-4C99-AC1D-3342DEA67A38}" type="datetimeFigureOut">
              <a:rPr lang="en-US" smtClean="0"/>
              <a:t>3/2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75B61C-C1C8-4546-B7B3-2B280C36BB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70931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20040" y="329566"/>
            <a:ext cx="5760720" cy="13716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20040" y="1842136"/>
            <a:ext cx="2828132" cy="767714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0040" y="2609850"/>
            <a:ext cx="2828132" cy="474154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251518" y="1842136"/>
            <a:ext cx="2829243" cy="767714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251518" y="2609850"/>
            <a:ext cx="2829243" cy="474154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B8CD5-3A83-4C99-AC1D-3342DEA67A38}" type="datetimeFigureOut">
              <a:rPr lang="en-US" smtClean="0"/>
              <a:t>3/28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75B61C-C1C8-4546-B7B3-2B280C36BB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66769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B8CD5-3A83-4C99-AC1D-3342DEA67A38}" type="datetimeFigureOut">
              <a:rPr lang="en-US" smtClean="0"/>
              <a:t>3/28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75B61C-C1C8-4546-B7B3-2B280C36BB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67001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B8CD5-3A83-4C99-AC1D-3342DEA67A38}" type="datetimeFigureOut">
              <a:rPr lang="en-US" smtClean="0"/>
              <a:t>3/28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75B61C-C1C8-4546-B7B3-2B280C36BB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08753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20040" y="327660"/>
            <a:ext cx="2105819" cy="139446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502535" y="327660"/>
            <a:ext cx="3578225" cy="7023736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20040" y="1722120"/>
            <a:ext cx="2105819" cy="5629276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B8CD5-3A83-4C99-AC1D-3342DEA67A38}" type="datetimeFigureOut">
              <a:rPr lang="en-US" smtClean="0"/>
              <a:t>3/2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75B61C-C1C8-4546-B7B3-2B280C36BB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37334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54602" y="5760720"/>
            <a:ext cx="3840480" cy="680086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254602" y="735330"/>
            <a:ext cx="3840480" cy="493776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54602" y="6440806"/>
            <a:ext cx="3840480" cy="965834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B8CD5-3A83-4C99-AC1D-3342DEA67A38}" type="datetimeFigureOut">
              <a:rPr lang="en-US" smtClean="0"/>
              <a:t>3/2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75B61C-C1C8-4546-B7B3-2B280C36BB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84253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20040" y="329566"/>
            <a:ext cx="5760720" cy="13716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20040" y="1920240"/>
            <a:ext cx="5760720" cy="543115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20040" y="7627621"/>
            <a:ext cx="1493520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EB8CD5-3A83-4C99-AC1D-3342DEA67A38}" type="datetimeFigureOut">
              <a:rPr lang="en-US" smtClean="0"/>
              <a:t>3/2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186940" y="7627621"/>
            <a:ext cx="2026920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87240" y="7627621"/>
            <a:ext cx="1493520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75B61C-C1C8-4546-B7B3-2B280C36BB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46998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4267200" y="0"/>
            <a:ext cx="2209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S1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9" name="Chart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87100191"/>
              </p:ext>
            </p:extLst>
          </p:nvPr>
        </p:nvGraphicFramePr>
        <p:xfrm>
          <a:off x="381000" y="1028700"/>
          <a:ext cx="1828800" cy="1828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0" name="Chart 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48227303"/>
              </p:ext>
            </p:extLst>
          </p:nvPr>
        </p:nvGraphicFramePr>
        <p:xfrm>
          <a:off x="2400300" y="1028700"/>
          <a:ext cx="1828800" cy="1828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1" name="Chart 1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00426023"/>
              </p:ext>
            </p:extLst>
          </p:nvPr>
        </p:nvGraphicFramePr>
        <p:xfrm>
          <a:off x="4419600" y="1028700"/>
          <a:ext cx="1828800" cy="1828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7" name="TextBox 6"/>
          <p:cNvSpPr txBox="1"/>
          <p:nvPr/>
        </p:nvSpPr>
        <p:spPr>
          <a:xfrm rot="16200000">
            <a:off x="1630107" y="1815622"/>
            <a:ext cx="146939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elative Viability (%)</a:t>
            </a:r>
          </a:p>
        </p:txBody>
      </p:sp>
      <p:grpSp>
        <p:nvGrpSpPr>
          <p:cNvPr id="2" name="Group 1"/>
          <p:cNvGrpSpPr/>
          <p:nvPr/>
        </p:nvGrpSpPr>
        <p:grpSpPr>
          <a:xfrm>
            <a:off x="-448117" y="2756442"/>
            <a:ext cx="2577167" cy="369332"/>
            <a:chOff x="-449254" y="3146539"/>
            <a:chExt cx="2577167" cy="369332"/>
          </a:xfrm>
        </p:grpSpPr>
        <p:sp>
          <p:nvSpPr>
            <p:cNvPr id="12" name="TextBox 11"/>
            <p:cNvSpPr txBox="1"/>
            <p:nvPr/>
          </p:nvSpPr>
          <p:spPr>
            <a:xfrm>
              <a:off x="-449254" y="3146539"/>
              <a:ext cx="130305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9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AgNP</a:t>
              </a:r>
              <a:endParaRPr lang="en-US" sz="900" b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US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µg/ml)</a:t>
              </a: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845850" y="3200400"/>
              <a:ext cx="20574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en-US" sz="800" b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 flipH="1">
              <a:off x="1173707" y="3200400"/>
              <a:ext cx="4572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lang="en-US" sz="800" b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1518313" y="3200400"/>
              <a:ext cx="6096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lang="en-US" sz="800" b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6" name="Group 15"/>
          <p:cNvGrpSpPr/>
          <p:nvPr/>
        </p:nvGrpSpPr>
        <p:grpSpPr>
          <a:xfrm>
            <a:off x="1594512" y="2764136"/>
            <a:ext cx="2577167" cy="369332"/>
            <a:chOff x="-449254" y="3146539"/>
            <a:chExt cx="2577167" cy="369332"/>
          </a:xfrm>
        </p:grpSpPr>
        <p:sp>
          <p:nvSpPr>
            <p:cNvPr id="17" name="TextBox 16"/>
            <p:cNvSpPr txBox="1"/>
            <p:nvPr/>
          </p:nvSpPr>
          <p:spPr>
            <a:xfrm>
              <a:off x="-449254" y="3146539"/>
              <a:ext cx="130305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9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AgNP</a:t>
              </a:r>
              <a:endParaRPr lang="en-US" sz="900" b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US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(µg/ml)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845850" y="3200400"/>
              <a:ext cx="20574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en-US" sz="800" b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 flipH="1">
              <a:off x="1173707" y="3200400"/>
              <a:ext cx="4572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lang="en-US" sz="800" b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1518313" y="3200400"/>
              <a:ext cx="6096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lang="en-US" sz="800" b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1" name="Group 20"/>
          <p:cNvGrpSpPr/>
          <p:nvPr/>
        </p:nvGrpSpPr>
        <p:grpSpPr>
          <a:xfrm>
            <a:off x="3609859" y="2756442"/>
            <a:ext cx="2577167" cy="369332"/>
            <a:chOff x="-449254" y="3146539"/>
            <a:chExt cx="2577167" cy="369332"/>
          </a:xfrm>
        </p:grpSpPr>
        <p:sp>
          <p:nvSpPr>
            <p:cNvPr id="22" name="TextBox 21"/>
            <p:cNvSpPr txBox="1"/>
            <p:nvPr/>
          </p:nvSpPr>
          <p:spPr>
            <a:xfrm>
              <a:off x="-449254" y="3146539"/>
              <a:ext cx="130305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9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AgNP</a:t>
              </a:r>
              <a:endParaRPr lang="en-US" sz="900" b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US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(µg/ml)</a:t>
              </a: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845850" y="3200400"/>
              <a:ext cx="20574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en-US" sz="800" b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TextBox 23"/>
            <p:cNvSpPr txBox="1"/>
            <p:nvPr/>
          </p:nvSpPr>
          <p:spPr>
            <a:xfrm flipH="1">
              <a:off x="1173707" y="3200400"/>
              <a:ext cx="4572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lang="en-US" sz="800" b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1518313" y="3200400"/>
              <a:ext cx="6096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lang="en-US" sz="800" b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6" name="TextBox 25"/>
          <p:cNvSpPr txBox="1"/>
          <p:nvPr/>
        </p:nvSpPr>
        <p:spPr>
          <a:xfrm>
            <a:off x="1119539" y="848742"/>
            <a:ext cx="609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2780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3052603" y="838200"/>
            <a:ext cx="74326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KOV3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5110003" y="838773"/>
            <a:ext cx="762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OVCAR3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1298347" y="1101211"/>
            <a:ext cx="20820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1727552" y="1219200"/>
            <a:ext cx="20820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3741509" y="1219200"/>
            <a:ext cx="20820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0" y="405950"/>
            <a:ext cx="3857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10549" y="3352800"/>
            <a:ext cx="3857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6" name="Chart 3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057962"/>
              </p:ext>
            </p:extLst>
          </p:nvPr>
        </p:nvGraphicFramePr>
        <p:xfrm>
          <a:off x="4558352" y="3632650"/>
          <a:ext cx="1627632" cy="162763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37" name="Chart 3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23376451"/>
              </p:ext>
            </p:extLst>
          </p:nvPr>
        </p:nvGraphicFramePr>
        <p:xfrm>
          <a:off x="2520786" y="3632650"/>
          <a:ext cx="1627632" cy="162763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38" name="Chart 3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50798880"/>
              </p:ext>
            </p:extLst>
          </p:nvPr>
        </p:nvGraphicFramePr>
        <p:xfrm>
          <a:off x="481693" y="3633780"/>
          <a:ext cx="1629159" cy="162537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39" name="TextBox 38"/>
          <p:cNvSpPr txBox="1"/>
          <p:nvPr/>
        </p:nvSpPr>
        <p:spPr>
          <a:xfrm>
            <a:off x="1119539" y="3466891"/>
            <a:ext cx="609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2780</a:t>
            </a:r>
          </a:p>
        </p:txBody>
      </p:sp>
      <p:sp>
        <p:nvSpPr>
          <p:cNvPr id="40" name="TextBox 39"/>
          <p:cNvSpPr txBox="1"/>
          <p:nvPr/>
        </p:nvSpPr>
        <p:spPr>
          <a:xfrm>
            <a:off x="3019509" y="3469420"/>
            <a:ext cx="74326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KOV3</a:t>
            </a:r>
          </a:p>
        </p:txBody>
      </p:sp>
      <p:sp>
        <p:nvSpPr>
          <p:cNvPr id="41" name="TextBox 40"/>
          <p:cNvSpPr txBox="1"/>
          <p:nvPr/>
        </p:nvSpPr>
        <p:spPr>
          <a:xfrm>
            <a:off x="5120226" y="3466892"/>
            <a:ext cx="762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OVCAR3</a:t>
            </a:r>
          </a:p>
        </p:txBody>
      </p:sp>
      <p:sp>
        <p:nvSpPr>
          <p:cNvPr id="42" name="TextBox 41"/>
          <p:cNvSpPr txBox="1"/>
          <p:nvPr/>
        </p:nvSpPr>
        <p:spPr>
          <a:xfrm rot="16200000">
            <a:off x="-338432" y="4280201"/>
            <a:ext cx="146939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old GSH</a:t>
            </a:r>
          </a:p>
        </p:txBody>
      </p:sp>
      <p:sp>
        <p:nvSpPr>
          <p:cNvPr id="43" name="TextBox 42"/>
          <p:cNvSpPr txBox="1"/>
          <p:nvPr/>
        </p:nvSpPr>
        <p:spPr>
          <a:xfrm rot="16200000">
            <a:off x="1705936" y="4280202"/>
            <a:ext cx="146939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old GSH</a:t>
            </a:r>
          </a:p>
        </p:txBody>
      </p:sp>
      <p:sp>
        <p:nvSpPr>
          <p:cNvPr id="44" name="TextBox 43"/>
          <p:cNvSpPr txBox="1"/>
          <p:nvPr/>
        </p:nvSpPr>
        <p:spPr>
          <a:xfrm rot="16200000">
            <a:off x="3770193" y="4280201"/>
            <a:ext cx="146939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old GSH</a:t>
            </a:r>
          </a:p>
        </p:txBody>
      </p:sp>
      <p:sp>
        <p:nvSpPr>
          <p:cNvPr id="46" name="TextBox 45"/>
          <p:cNvSpPr txBox="1"/>
          <p:nvPr/>
        </p:nvSpPr>
        <p:spPr>
          <a:xfrm rot="16200000">
            <a:off x="3666101" y="1815623"/>
            <a:ext cx="146939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elative Viability (%)</a:t>
            </a:r>
          </a:p>
        </p:txBody>
      </p:sp>
      <p:sp>
        <p:nvSpPr>
          <p:cNvPr id="47" name="TextBox 46"/>
          <p:cNvSpPr txBox="1"/>
          <p:nvPr/>
        </p:nvSpPr>
        <p:spPr>
          <a:xfrm rot="16200000">
            <a:off x="-415874" y="1838482"/>
            <a:ext cx="146939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elative Viability (%)</a:t>
            </a:r>
          </a:p>
        </p:txBody>
      </p:sp>
    </p:spTree>
    <p:extLst>
      <p:ext uri="{BB962C8B-B14F-4D97-AF65-F5344CB8AC3E}">
        <p14:creationId xmlns:p14="http://schemas.microsoft.com/office/powerpoint/2010/main" val="122009704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7117</TotalTime>
  <Words>52</Words>
  <Application>Microsoft Office PowerPoint</Application>
  <PresentationFormat>Custom</PresentationFormat>
  <Paragraphs>3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WFUHS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ale D. Fahrenholtz</dc:creator>
  <cp:lastModifiedBy>Ravi Singh</cp:lastModifiedBy>
  <cp:revision>224</cp:revision>
  <dcterms:created xsi:type="dcterms:W3CDTF">2016-02-18T16:20:22Z</dcterms:created>
  <dcterms:modified xsi:type="dcterms:W3CDTF">2017-03-28T17:54:33Z</dcterms:modified>
</cp:coreProperties>
</file>